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4599B-F93D-DCCD-48FE-E8D6763C31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D8ECBCA-23D8-A94B-735D-022750C608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B8B818-56E3-5FDA-563F-BB8B3BDF3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27587D-9D58-2401-A440-1C4F3724D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4730B4-C3C3-23E7-AAAE-D52552186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082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B78EA4-21EF-E95F-AEA7-282DE53953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A03F9A-B69D-BF98-D0BF-A0049F851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2D63AA-6175-8272-0170-118C00AB9D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9D89FA-292F-B8B7-8E39-0A9251F7CD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9BB115-8651-64EA-A060-5C34229348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9741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411517-2F99-21FC-FF9B-A3D19A553E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266705-F15A-B133-74DD-D5E879EE9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AAE95C-5792-348F-88CB-B24E74ACDB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DDE9F-A203-E4F8-2A27-8C5C8F6AD6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7D4A2C-8277-A501-FF5C-8743BC5478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08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EDDDB8-920D-4445-534E-4B172AF065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5E4D3-DF69-DAA5-FC31-041FB8EA65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ADBDF-5563-A4AB-9667-B04719794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2C1F96-39C9-ADF6-ED01-B37A739F5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838EA0-2FA6-59F5-7AAF-B8C199116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850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077103-EE6B-0F0E-849E-B451A4C68C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4623DC-429C-0958-3E1B-6B42F2BCCA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7D4172-2F3C-B368-5637-E30B96F13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66023C-1E09-8D93-4143-73EB19CB3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E2DC6-4BF1-5773-C54F-7594BEFD6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25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8DF3B0-2B6F-759D-3487-E1A1566B94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D55164-5672-DDF4-6BF2-5F5027307D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287619-4612-D63A-F0F0-57B0F03B36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3BCE3F-57B6-01BF-9793-198AF1649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9E3255-A0E3-4E40-12EA-D70755923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3A3F64-5C57-7BC6-9EA3-7A91B55BF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320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79E7D1-A58D-BF36-1C37-CB1ECF06BF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6B714C-9BC9-969C-15B5-682C092A21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2BBAC0-5664-C1AD-5B4A-073CC694B5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6CF51F-5CE8-29C0-1E9A-8190801F34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B6134F-C20D-AD7B-D0BC-7680719FFB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05765F-A406-FA0F-71AB-061D19637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05AB52C-89E2-01D5-F902-66D58F8C4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CFD79B0-2349-EB4B-65AC-BEE492CE3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459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557E2-B32F-4878-740A-C18E5E460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C8FA3C-EF0C-4AF1-1C2E-83BD50153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7E5C7D-A824-91C1-C1EB-2FFBCD53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B9D4CD-DBE9-6E5F-1743-C57A1A9CC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1351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9530656-0A86-8B6F-9878-9546E832B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6CA142-E3A7-2064-98E1-E62238D29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B55CF2-0BBB-DBDB-46D6-E857CDBE5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76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E9FC9-C422-58FA-2939-BE2EE31CC0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626AC2-4BAE-37C0-F1C0-FBFCCF9A98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F06DA8-8075-569E-2563-CA89569C52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3562E6-2750-3CC1-6CA4-7A113B41A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EDD253-9114-20BA-B2DD-F878FC1D5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EB05CA-19C0-071D-DB36-A63FE91A6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48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9B6E9-DC05-4945-C153-6CF75780E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6DDF63-4F53-5818-0243-FD29284441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58311E-2F1C-6415-B46F-17B6F133B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C3151-D418-EF44-8CF0-C828B29F8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FFB2E1-CE48-1719-6EA8-15FC40E338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7EFDBD-6491-05BE-AB66-834C214D3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875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F5F76D-4D78-9410-CBB4-06635C36B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5FE8F0-FC23-80DC-88F8-AE0E1EEE46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872130-7057-A9CC-CFC9-1F3F854C026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34DDA-CB71-414E-BC99-2484C9E299AC}" type="datetimeFigureOut">
              <a:rPr lang="en-US" smtClean="0"/>
              <a:t>8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B3B7DA-64A8-2CBB-A4E9-5B4D9396D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F56305-8EEA-3960-713B-82580782D8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9CC381-125D-4299-846A-58C2BC1BDC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76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9CFBDB3-4BFB-716C-97B0-80B55DCC34BE}"/>
              </a:ext>
            </a:extLst>
          </p:cNvPr>
          <p:cNvSpPr txBox="1"/>
          <p:nvPr/>
        </p:nvSpPr>
        <p:spPr>
          <a:xfrm>
            <a:off x="85725" y="5724525"/>
            <a:ext cx="1166812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600"/>
              </a:spcBef>
              <a:spcAft>
                <a:spcPts val="1200"/>
              </a:spcAft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6. Observed phenotype versus predicted cross-validation predictions for four models (M1-M4) under the cross-validation scheme CV1 which mimics the prediction scenario of newly developed lines (predicting untested genotypes in observed environments). Horizontal and vertical dashed lines indicate the 20, 50 and 80 % empirical percentiles corresponding to the observed and predicted values; the numbers inside the grid give the conditional proportions observed in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y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axis for the different percentiles in the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axis (e.g., out of the top 20% of the predicted values with M3 (panel C), 71% [top right] of these correspond to phenotypes that showed a performance among </a:t>
            </a:r>
            <a:r>
              <a:rPr lang="en-US" sz="14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e top 20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% in fields).</a:t>
            </a:r>
          </a:p>
        </p:txBody>
      </p:sp>
      <p:pic>
        <p:nvPicPr>
          <p:cNvPr id="4" name="Picture 3" descr="Map&#10;&#10;Description automatically generated">
            <a:extLst>
              <a:ext uri="{FF2B5EF4-FFF2-40B4-BE49-F238E27FC236}">
                <a16:creationId xmlns:a16="http://schemas.microsoft.com/office/drawing/2014/main" id="{D4CF545B-4D39-63B3-81B4-9DF8C95C3C6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91802" y="5200"/>
            <a:ext cx="5584906" cy="558490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283413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rnandez Jarquin,Juan Diego</dc:creator>
  <cp:lastModifiedBy>Hernandez Jarquin,Juan Diego</cp:lastModifiedBy>
  <cp:revision>5</cp:revision>
  <dcterms:created xsi:type="dcterms:W3CDTF">2022-08-30T03:12:47Z</dcterms:created>
  <dcterms:modified xsi:type="dcterms:W3CDTF">2022-08-30T03:43:37Z</dcterms:modified>
</cp:coreProperties>
</file>